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9845" autoAdjust="0"/>
  </p:normalViewPr>
  <p:slideViewPr>
    <p:cSldViewPr snapToGrid="0" snapToObjects="1">
      <p:cViewPr>
        <p:scale>
          <a:sx n="150" d="100"/>
          <a:sy n="150" d="100"/>
        </p:scale>
        <p:origin x="-80" y="4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1120FA-737A-9C4A-B318-F83D542226E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E3EA4D-95A0-4446-9D62-6D72EFDD4C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9016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6310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6064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568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237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285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764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078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7883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779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825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210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3172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29920" y="343723"/>
            <a:ext cx="785108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/>
              <a:t>Supplementary figure S4; </a:t>
            </a:r>
            <a:r>
              <a:rPr lang="en-US" sz="1500" dirty="0"/>
              <a:t>Correlation of gene expression changes after </a:t>
            </a:r>
            <a:r>
              <a:rPr lang="en-US" sz="1500" dirty="0" err="1"/>
              <a:t>OvX</a:t>
            </a:r>
            <a:r>
              <a:rPr lang="en-US" sz="1500" dirty="0"/>
              <a:t> and AI therapy for (A ) all probes that passed filtration (12716) and for (B) putative progesterone regulated genes (n</a:t>
            </a:r>
            <a:r>
              <a:rPr lang="en-US" sz="1500" dirty="0" smtClean="0"/>
              <a:t>=144)</a:t>
            </a:r>
            <a:endParaRPr lang="en-GB" sz="1500" dirty="0"/>
          </a:p>
        </p:txBody>
      </p:sp>
      <p:sp>
        <p:nvSpPr>
          <p:cNvPr id="7" name="TextBox 6"/>
          <p:cNvSpPr txBox="1"/>
          <p:nvPr/>
        </p:nvSpPr>
        <p:spPr>
          <a:xfrm>
            <a:off x="707066" y="1215541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5307325" y="1215541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772499" y="1554103"/>
            <a:ext cx="348044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 smtClean="0"/>
              <a:t>12716 probes detectable in &gt;25% samples </a:t>
            </a:r>
            <a:endParaRPr lang="en-US" sz="1500" dirty="0"/>
          </a:p>
        </p:txBody>
      </p:sp>
      <p:sp>
        <p:nvSpPr>
          <p:cNvPr id="12" name="Rectangle 11"/>
          <p:cNvSpPr/>
          <p:nvPr/>
        </p:nvSpPr>
        <p:spPr>
          <a:xfrm>
            <a:off x="4990579" y="1554103"/>
            <a:ext cx="3893426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500" dirty="0" smtClean="0"/>
              <a:t>Putative progesterone-regulated genes (n=144)</a:t>
            </a:r>
            <a:endParaRPr lang="en-US" sz="1500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2199" y="2217186"/>
            <a:ext cx="3341534" cy="301457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61538" y="2134334"/>
            <a:ext cx="3367061" cy="30296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74250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1</TotalTime>
  <Words>60</Words>
  <Application>Microsoft Macintosh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</dc:creator>
  <cp:lastModifiedBy>b</cp:lastModifiedBy>
  <cp:revision>53</cp:revision>
  <cp:lastPrinted>2016-12-20T15:36:47Z</cp:lastPrinted>
  <dcterms:created xsi:type="dcterms:W3CDTF">2016-09-14T15:46:14Z</dcterms:created>
  <dcterms:modified xsi:type="dcterms:W3CDTF">2017-04-28T12:56:06Z</dcterms:modified>
</cp:coreProperties>
</file>